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1386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F9FF3A-F7FE-5F4B-BB05-0012EE8A38C4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0F82F-1481-1540-BACE-77F5D0D30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26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00F82F-1481-1540-BACE-77F5D0D30D3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909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648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033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703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068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761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256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956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614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429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178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869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87225-51C1-1541-B512-D4A0A00CB6A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243633-95C8-C848-9ABD-BDB4B26843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727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0" y="135072"/>
            <a:ext cx="9085926" cy="3928830"/>
            <a:chOff x="-66927" y="1112997"/>
            <a:chExt cx="9085926" cy="3928830"/>
          </a:xfrm>
        </p:grpSpPr>
        <p:pic>
          <p:nvPicPr>
            <p:cNvPr id="5" name="Picture 4" descr="IMG_20230613_090621_362.jp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8" t="36671" r="17469" b="10619"/>
            <a:stretch/>
          </p:blipFill>
          <p:spPr>
            <a:xfrm>
              <a:off x="1091219" y="1232015"/>
              <a:ext cx="7927780" cy="3809812"/>
            </a:xfrm>
            <a:prstGeom prst="rect">
              <a:avLst/>
            </a:prstGeom>
            <a:ln>
              <a:solidFill>
                <a:srgbClr val="4F81BD"/>
              </a:solidFill>
            </a:ln>
          </p:spPr>
        </p:pic>
        <p:sp>
          <p:nvSpPr>
            <p:cNvPr id="2" name="ZoneTexte 1"/>
            <p:cNvSpPr txBox="1"/>
            <p:nvPr/>
          </p:nvSpPr>
          <p:spPr>
            <a:xfrm>
              <a:off x="1954190" y="1129136"/>
              <a:ext cx="4451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1</a:t>
              </a:r>
              <a:endParaRPr lang="fr-FR" sz="2000" b="1" dirty="0"/>
            </a:p>
          </p:txBody>
        </p:sp>
        <p:sp>
          <p:nvSpPr>
            <p:cNvPr id="3" name="ZoneTexte 2"/>
            <p:cNvSpPr txBox="1"/>
            <p:nvPr/>
          </p:nvSpPr>
          <p:spPr>
            <a:xfrm>
              <a:off x="2279043" y="1115626"/>
              <a:ext cx="4211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2</a:t>
              </a:r>
              <a:endParaRPr lang="fr-FR" sz="2000" b="1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2677400" y="1129297"/>
              <a:ext cx="4932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 3</a:t>
              </a:r>
              <a:endParaRPr lang="fr-FR" sz="2000" b="1" dirty="0"/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3207800" y="1123935"/>
              <a:ext cx="4543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4</a:t>
              </a:r>
              <a:endParaRPr lang="fr-FR" sz="2000" b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3571419" y="1123935"/>
              <a:ext cx="4812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 5</a:t>
              </a:r>
              <a:endParaRPr lang="fr-FR" sz="20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020703" y="1126507"/>
              <a:ext cx="43313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6</a:t>
              </a:r>
              <a:endParaRPr lang="fr-FR" sz="20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4446866" y="1112997"/>
              <a:ext cx="46923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 7</a:t>
              </a:r>
              <a:endParaRPr lang="fr-FR" sz="2000" b="1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4946323" y="1117505"/>
              <a:ext cx="55291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8</a:t>
              </a:r>
              <a:endParaRPr lang="fr-FR" sz="2000" b="1" dirty="0"/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5294758" y="1126507"/>
              <a:ext cx="51735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 9</a:t>
              </a:r>
              <a:endParaRPr lang="fr-FR" sz="2000" b="1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5704396" y="1169609"/>
              <a:ext cx="61361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10</a:t>
              </a:r>
              <a:endParaRPr lang="fr-FR" sz="2000" b="1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6141793" y="1158035"/>
              <a:ext cx="5414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 11</a:t>
              </a:r>
              <a:endParaRPr lang="fr-FR" sz="2000" b="1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6667913" y="1136029"/>
              <a:ext cx="4692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12</a:t>
              </a:r>
              <a:endParaRPr lang="fr-FR" sz="2000" b="1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7110120" y="1136029"/>
              <a:ext cx="4572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13</a:t>
              </a:r>
              <a:endParaRPr lang="fr-FR" sz="2000" b="1" dirty="0"/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7508500" y="1136029"/>
              <a:ext cx="4812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PC</a:t>
              </a:r>
              <a:endParaRPr lang="fr-FR" sz="2000" b="1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7893390" y="1120077"/>
              <a:ext cx="5414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/>
                <a:t>NC</a:t>
              </a:r>
              <a:endParaRPr lang="fr-FR" sz="2000" b="1" dirty="0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421105" y="1600200"/>
              <a:ext cx="99260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421105" y="1371600"/>
              <a:ext cx="7700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553453" y="1600200"/>
              <a:ext cx="637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421105" y="1556266"/>
              <a:ext cx="9023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505326" y="1556266"/>
              <a:ext cx="81814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sz="2000" b="1" dirty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421105" y="1556266"/>
              <a:ext cx="7700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961422" y="1502387"/>
              <a:ext cx="24108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2000" b="1" dirty="0" smtClean="0">
                  <a:solidFill>
                    <a:schemeClr val="bg1"/>
                  </a:solidFill>
                </a:rPr>
                <a:t>  100 </a:t>
              </a:r>
              <a:r>
                <a:rPr lang="fr-FR" sz="2000" b="1" dirty="0" err="1" smtClean="0">
                  <a:solidFill>
                    <a:schemeClr val="bg1"/>
                  </a:solidFill>
                </a:rPr>
                <a:t>bp</a:t>
              </a:r>
              <a:r>
                <a:rPr lang="fr-FR" sz="2000" b="1" dirty="0" smtClean="0">
                  <a:solidFill>
                    <a:schemeClr val="bg1"/>
                  </a:solidFill>
                </a:rPr>
                <a:t> DNA </a:t>
              </a:r>
              <a:r>
                <a:rPr lang="fr-FR" sz="2000" b="1" dirty="0" err="1">
                  <a:solidFill>
                    <a:schemeClr val="bg1"/>
                  </a:solidFill>
                </a:rPr>
                <a:t>L</a:t>
              </a:r>
              <a:r>
                <a:rPr lang="fr-FR" sz="2000" b="1" dirty="0" err="1" smtClean="0">
                  <a:solidFill>
                    <a:schemeClr val="bg1"/>
                  </a:solidFill>
                </a:rPr>
                <a:t>adder</a:t>
              </a:r>
              <a:r>
                <a:rPr lang="fr-FR" sz="2000" b="1" dirty="0" smtClean="0">
                  <a:solidFill>
                    <a:schemeClr val="bg1"/>
                  </a:solidFill>
                </a:rPr>
                <a:t> </a:t>
              </a: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-47210" y="2799711"/>
              <a:ext cx="1561709" cy="400110"/>
              <a:chOff x="-47210" y="2799711"/>
              <a:chExt cx="1561709" cy="400110"/>
            </a:xfrm>
          </p:grpSpPr>
          <p:sp>
            <p:nvSpPr>
              <p:cNvPr id="25" name="ZoneTexte 24"/>
              <p:cNvSpPr txBox="1"/>
              <p:nvPr/>
            </p:nvSpPr>
            <p:spPr>
              <a:xfrm>
                <a:off x="-47210" y="2799711"/>
                <a:ext cx="102720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000" b="1" dirty="0" smtClean="0"/>
                  <a:t>500 </a:t>
                </a:r>
                <a:r>
                  <a:rPr lang="fr-FR" sz="2000" b="1" dirty="0" err="1" smtClean="0"/>
                  <a:t>bp</a:t>
                </a:r>
                <a:endParaRPr lang="fr-FR" sz="2000" b="1" dirty="0"/>
              </a:p>
            </p:txBody>
          </p:sp>
          <p:cxnSp>
            <p:nvCxnSpPr>
              <p:cNvPr id="14" name="Straight Connector 13"/>
              <p:cNvCxnSpPr/>
              <p:nvPr/>
            </p:nvCxnSpPr>
            <p:spPr>
              <a:xfrm>
                <a:off x="798619" y="3082881"/>
                <a:ext cx="715880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Group 38"/>
            <p:cNvGrpSpPr/>
            <p:nvPr/>
          </p:nvGrpSpPr>
          <p:grpSpPr>
            <a:xfrm>
              <a:off x="-66927" y="3938339"/>
              <a:ext cx="1561709" cy="400110"/>
              <a:chOff x="-47210" y="2799711"/>
              <a:chExt cx="1561709" cy="400110"/>
            </a:xfrm>
          </p:grpSpPr>
          <p:sp>
            <p:nvSpPr>
              <p:cNvPr id="40" name="ZoneTexte 24"/>
              <p:cNvSpPr txBox="1"/>
              <p:nvPr/>
            </p:nvSpPr>
            <p:spPr>
              <a:xfrm>
                <a:off x="-47210" y="2799711"/>
                <a:ext cx="102720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2000" b="1" dirty="0"/>
                  <a:t>1</a:t>
                </a:r>
                <a:r>
                  <a:rPr lang="fr-FR" sz="2000" b="1" dirty="0" smtClean="0"/>
                  <a:t>00 </a:t>
                </a:r>
                <a:r>
                  <a:rPr lang="fr-FR" sz="2000" b="1" dirty="0" err="1" smtClean="0"/>
                  <a:t>bp</a:t>
                </a:r>
                <a:endParaRPr lang="fr-FR" sz="2000" b="1" dirty="0"/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798619" y="3082881"/>
                <a:ext cx="715880" cy="0"/>
              </a:xfrm>
              <a:prstGeom prst="line">
                <a:avLst/>
              </a:prstGeom>
              <a:ln w="762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5" name="Rectangle 44"/>
          <p:cNvSpPr/>
          <p:nvPr/>
        </p:nvSpPr>
        <p:spPr>
          <a:xfrm>
            <a:off x="-56788" y="4119331"/>
            <a:ext cx="9344229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Legend:</a:t>
            </a:r>
          </a:p>
          <a:p>
            <a:r>
              <a:rPr lang="en-US" sz="2000" dirty="0" err="1"/>
              <a:t>bp</a:t>
            </a:r>
            <a:r>
              <a:rPr lang="en-US" sz="2000" dirty="0"/>
              <a:t>: Base pair</a:t>
            </a:r>
          </a:p>
          <a:p>
            <a:r>
              <a:rPr lang="en-US" sz="2000" dirty="0"/>
              <a:t>Numbering: Wells 1 to 13 represent the numbering of the wells containing PCR </a:t>
            </a:r>
            <a:r>
              <a:rPr lang="en-US" sz="2000" dirty="0" smtClean="0"/>
              <a:t>products</a:t>
            </a:r>
            <a:endParaRPr lang="en-US" sz="2000" dirty="0"/>
          </a:p>
          <a:p>
            <a:r>
              <a:rPr lang="en-US" sz="2000" dirty="0"/>
              <a:t>PC: Positive Control</a:t>
            </a:r>
          </a:p>
          <a:p>
            <a:r>
              <a:rPr lang="en-US" sz="2000" dirty="0"/>
              <a:t>NC: Negative Control</a:t>
            </a:r>
          </a:p>
        </p:txBody>
      </p:sp>
      <p:sp>
        <p:nvSpPr>
          <p:cNvPr id="46" name="Rectangle 45"/>
          <p:cNvSpPr/>
          <p:nvPr/>
        </p:nvSpPr>
        <p:spPr>
          <a:xfrm>
            <a:off x="226525" y="5981828"/>
            <a:ext cx="88594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400" dirty="0" smtClean="0"/>
              <a:t>Fig. </a:t>
            </a:r>
            <a:r>
              <a:rPr lang="en-US" sz="2400" dirty="0" smtClean="0"/>
              <a:t>S1: </a:t>
            </a:r>
            <a:r>
              <a:rPr lang="en-US" sz="2400" dirty="0"/>
              <a:t>Molecular Detection of Microsporidia MB in </a:t>
            </a:r>
            <a:r>
              <a:rPr lang="en-US" sz="2400" i="1" dirty="0"/>
              <a:t>Anopheles coluzzii </a:t>
            </a:r>
            <a:r>
              <a:rPr lang="en-US" sz="2400" dirty="0"/>
              <a:t>from Zinder City, Niger </a:t>
            </a:r>
            <a:r>
              <a:rPr lang="en-US" sz="2400" dirty="0" smtClean="0"/>
              <a:t>using </a:t>
            </a:r>
            <a:r>
              <a:rPr lang="en-US" sz="2400" dirty="0"/>
              <a:t>2% </a:t>
            </a:r>
            <a:r>
              <a:rPr lang="en-US" sz="2400" dirty="0" smtClean="0"/>
              <a:t>TBE </a:t>
            </a:r>
            <a:r>
              <a:rPr lang="en-US" sz="2400" dirty="0"/>
              <a:t>a</a:t>
            </a:r>
            <a:r>
              <a:rPr lang="en-US" sz="2400" dirty="0" smtClean="0"/>
              <a:t>garose </a:t>
            </a:r>
            <a:r>
              <a:rPr lang="en-US" sz="2400" dirty="0"/>
              <a:t>g</a:t>
            </a:r>
            <a:r>
              <a:rPr lang="en-US" sz="2400" dirty="0" smtClean="0"/>
              <a:t>el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410737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8</TotalTime>
  <Words>86</Words>
  <Application>Microsoft Office PowerPoint</Application>
  <PresentationFormat>On-screen Show (4:3)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IRSS/Centre Muraz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tienne Bilgo</dc:creator>
  <cp:lastModifiedBy>Indhumathi</cp:lastModifiedBy>
  <cp:revision>16</cp:revision>
  <dcterms:created xsi:type="dcterms:W3CDTF">2023-06-20T13:57:44Z</dcterms:created>
  <dcterms:modified xsi:type="dcterms:W3CDTF">2023-11-30T13:23:49Z</dcterms:modified>
</cp:coreProperties>
</file>